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1647E5-6EDA-4A75-B28D-009E2B84D04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42490D-2B58-44E6-9C24-91856CBFE7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3F852-4DA2-4151-96C6-FBD8BC23D2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71A179-F8DD-4171-A10A-A51822179A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C6443E-3BF4-44D3-84F6-1686B76307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A22BFE-1D3B-454F-8D64-AFE045C2A8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0334D5-538A-43D5-8E75-7C1659ED09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48EC66-FF28-4D2B-A8E3-11538425BA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77B85-2B1F-4292-A4C4-7DCEF40B4B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21E9C1-2E06-4DE4-82E3-CEDC6A8A17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263192-0535-4DEC-9220-48FE5446C2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6DC47-1964-40B1-AB0A-9CCB05E37C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D06E1E-F497-4751-9253-4BE6356B545B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02920" y="582480"/>
            <a:ext cx="18478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Supplemental file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037880" y="2368440"/>
            <a:ext cx="69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PAR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741320" y="2500200"/>
            <a:ext cx="344520" cy="3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727280" y="2855880"/>
            <a:ext cx="344520" cy="3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949680" y="19335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069200" y="272412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189800" y="4940280"/>
            <a:ext cx="352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L-1 (pg/ml)           0        1         10      100    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037520" y="4173480"/>
            <a:ext cx="68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PAR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792440" y="4303800"/>
            <a:ext cx="344160" cy="32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778040" y="4659480"/>
            <a:ext cx="344520" cy="2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920" bIns="-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119960" y="452772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063800" y="1946160"/>
            <a:ext cx="18396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951120" y="36608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2232000" y="2735280"/>
            <a:ext cx="2468520" cy="25560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2"/>
          <a:stretch/>
        </p:blipFill>
        <p:spPr>
          <a:xfrm>
            <a:off x="2232000" y="2422440"/>
            <a:ext cx="2468520" cy="158760"/>
          </a:xfrm>
          <a:prstGeom prst="rect">
            <a:avLst/>
          </a:prstGeom>
          <a:ln w="0">
            <a:noFill/>
          </a:ln>
        </p:spPr>
      </p:pic>
      <p:pic>
        <p:nvPicPr>
          <p:cNvPr id="56" name="" descr=""/>
          <p:cNvPicPr/>
          <p:nvPr/>
        </p:nvPicPr>
        <p:blipFill>
          <a:blip r:embed="rId3"/>
          <a:stretch/>
        </p:blipFill>
        <p:spPr>
          <a:xfrm>
            <a:off x="2306520" y="4567320"/>
            <a:ext cx="2468520" cy="198360"/>
          </a:xfrm>
          <a:prstGeom prst="rect">
            <a:avLst/>
          </a:prstGeom>
          <a:ln w="0">
            <a:noFill/>
          </a:ln>
        </p:spPr>
      </p:pic>
      <p:pic>
        <p:nvPicPr>
          <p:cNvPr id="57" name="" descr=""/>
          <p:cNvPicPr/>
          <p:nvPr/>
        </p:nvPicPr>
        <p:blipFill>
          <a:blip r:embed="rId4"/>
          <a:stretch/>
        </p:blipFill>
        <p:spPr>
          <a:xfrm>
            <a:off x="2276640" y="4208400"/>
            <a:ext cx="2468520" cy="19836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1244880" y="3110040"/>
            <a:ext cx="339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L-1 (pg/ml)        0        1         10      100    10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95160" y="5772240"/>
            <a:ext cx="53532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The effect of IL-1 on PPARa and PPARb protein expression in OA chondrocytes. Chondrocytes were treated with increasing concentrations of IL-1 for 24 hours. Cell lysates were prepared and analyzed for PPARa (A) and PPARb (B) expression by Western blotting (upper panels). The blots were stripped and reprobed with a specific anti-b-actin antibody (lower panels). The blots are representative of similar results obtained from four independent experiments performed with cells from four different donors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2-02T18:17:11Z</dcterms:created>
  <dc:creator>Admin</dc:creator>
  <dc:description/>
  <dc:language>en-US</dc:language>
  <cp:lastModifiedBy>Louise.Crane</cp:lastModifiedBy>
  <cp:lastPrinted>2006-10-18T20:21:28Z</cp:lastPrinted>
  <dcterms:modified xsi:type="dcterms:W3CDTF">2007-04-05T13:07:11Z</dcterms:modified>
  <cp:revision>228</cp:revision>
  <dc:subject/>
  <dc:title>Diapositive 1</dc:title>
</cp:coreProperties>
</file>